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0" r:id="rId2"/>
    <p:sldId id="279" r:id="rId3"/>
    <p:sldId id="280" r:id="rId4"/>
    <p:sldId id="281" r:id="rId5"/>
    <p:sldId id="28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 varScale="1">
        <p:scale>
          <a:sx n="67" d="100"/>
          <a:sy n="67" d="100"/>
        </p:scale>
        <p:origin x="8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6A09B-E284-416F-8C32-29AC445708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8BB011-C7D7-448A-B426-7DE6A77C63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E95395-2E06-4E27-A792-A836B4CAC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460058-E60E-4BEC-9DB9-C12ED8B0E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CC1A04-B3E1-42AD-BA93-9E7D64C2B0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623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5AD37B-4E65-4020-B6A5-3F083FE66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14EE4D-305D-4D04-95E8-9B69557FB9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91EA92-5F27-41EA-B053-8A50E64E9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2D1E53-7737-4BAD-B632-C59F27690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65EC67-0074-4A65-A49A-94E428E81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049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B5550E4-3679-4BE2-8921-AE4CD6A66A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94B704-A5E5-4AEC-BCAE-A81D3FB336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D09D14-7D42-438C-B84D-CEF9F4929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8B51E9-A783-482F-9A56-07B89BD98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7DBE55-0A17-472C-8294-DDD0C212E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05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A0B7D8-94D7-427C-878B-64AADCEF14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FFDD3B-913E-44DA-B3D8-00F9C6C5C2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C4ABE9-3E33-4B4C-BAD2-21C42A183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061D92-250B-40D8-B196-52F8050BE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C9BB35-2D5E-4DEE-B35D-05FFEFB8D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771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DD348F-C433-4107-90A8-25091D564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2C8AC7-F228-46DB-8F03-8529A865A5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892A3B-A01D-46E3-B3DC-B5AAC258D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C9E38C-F6C7-48A2-9C15-43BD205D9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5F01D3-B556-4F75-8847-1222F7EB4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655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128E24-A9CF-4483-BD3D-ECCCD5CF50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17891D-9FF2-4F5E-8F1B-AD49CB5946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F5192A-4BC1-4F92-9378-4D31049B26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37CFFF-9E83-4C87-8DBC-C7F219741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04F614-98C5-4A6C-BCF4-E7778E5FC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D7F0EB-5455-42E5-96EA-22AABEB12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419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C38B02-1545-48AA-84E6-2D161C3CBF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E4B353-5AB3-40D8-9D46-1290C86CB8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C0B6D8-150F-4A2A-8E0D-1F76185B0D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F5B9B6-8465-4D48-83B9-B9ED2BDCC2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101359-122C-4C73-916F-2C8F470FC7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49CE6B-AAAD-4D29-9492-D27A2A21A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A87D95-476C-49E3-891A-6D6EF0B18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8E7295-8C1D-49CC-8EDE-B5716BF7B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907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36106E-C96B-4379-8370-30DF38B02B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1022F2-05AF-44B5-ACB9-4AC5768A06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E43A30-344B-41DF-ADF8-9F988ADF6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0DCA8BB-B2FB-4F38-87E4-EBF21167A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02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78B2F87-2165-455D-9400-88B50CE96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AC6992-B7AF-4962-98B9-18ED71D1B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5668E6-0070-46D4-B957-F48D84E4D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444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152D22-E366-4C61-838B-3AD3437CC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62C9F3-4F80-4B2E-8DCA-3A6777FF08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4F78A5-3101-482F-B611-7BDEC70091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B7671A-1875-4CCD-9439-6FB1CD2FE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81656D-92C0-4927-9662-666B7E434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BFFF80-465C-4379-AC2A-A1F29B31A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189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A6D0BE-C320-49B2-9BE1-861A9BBF3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B44997-C4FE-4555-90D1-08D0D07325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5C3DDD-B84F-46D4-90D9-981EBD770A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44683A-BDCC-4815-8311-574AFE98F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9E89C9-2578-4851-B714-75523DB0C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CE29F7-F9B0-42C1-BEA5-08658F517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637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27DFB1F-50F2-407E-B16C-B028C49DFD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9436BD-B6F4-42D1-A227-39A4C9FE40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0A5EC-06C2-494E-8E25-5EF0E2C733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192BD-FB38-4CB7-BA97-7860E96FE4B3}" type="datetimeFigureOut">
              <a:rPr lang="en-US" smtClean="0"/>
              <a:t>4/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8DFB25-99D9-4AB8-819D-7A69484257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1C0AD1-0B45-43D5-92FE-3B12E260EE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123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96DE4CC-06D8-46FD-A64C-C9057340C269}"/>
              </a:ext>
            </a:extLst>
          </p:cNvPr>
          <p:cNvSpPr txBox="1"/>
          <p:nvPr/>
        </p:nvSpPr>
        <p:spPr>
          <a:xfrm>
            <a:off x="794774" y="1357312"/>
            <a:ext cx="10363764" cy="12372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2000" b="1" dirty="0"/>
              <a:t>Figure S1. </a:t>
            </a:r>
            <a:r>
              <a:rPr lang="en-US" sz="2000" dirty="0"/>
              <a:t>Scatter plot of IWGSC </a:t>
            </a:r>
            <a:r>
              <a:rPr lang="en-US" sz="2000" dirty="0" err="1"/>
              <a:t>RefSeq</a:t>
            </a:r>
            <a:r>
              <a:rPr lang="en-US" sz="2000" dirty="0"/>
              <a:t> v2.0 physical map against genetic map in each of the four mapping populations used in the present study.</a:t>
            </a:r>
            <a:endParaRPr lang="en-US" sz="2000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11301249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7FD3022-AC1A-4EBC-B723-2402F153A6EB}"/>
              </a:ext>
            </a:extLst>
          </p:cNvPr>
          <p:cNvSpPr txBox="1"/>
          <p:nvPr/>
        </p:nvSpPr>
        <p:spPr>
          <a:xfrm>
            <a:off x="7015164" y="5100641"/>
            <a:ext cx="4343400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Overall Pearson correlation = 0.39, p &lt; 000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EAA6BA2-1D65-4779-B674-AD8588DA68C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501"/>
          <a:stretch/>
        </p:blipFill>
        <p:spPr>
          <a:xfrm>
            <a:off x="490537" y="414338"/>
            <a:ext cx="8764930" cy="56435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29085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BA8E13B-0182-461D-B768-F6569F2002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3462" y="223837"/>
            <a:ext cx="9107534" cy="607695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1F25E1C-8116-497E-855B-D512BE915645}"/>
              </a:ext>
            </a:extLst>
          </p:cNvPr>
          <p:cNvSpPr txBox="1"/>
          <p:nvPr/>
        </p:nvSpPr>
        <p:spPr>
          <a:xfrm>
            <a:off x="7015164" y="5100641"/>
            <a:ext cx="4343400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Overall Pearson correlation = 0.55, p &lt; 0001</a:t>
            </a:r>
          </a:p>
        </p:txBody>
      </p:sp>
    </p:spTree>
    <p:extLst>
      <p:ext uri="{BB962C8B-B14F-4D97-AF65-F5344CB8AC3E}">
        <p14:creationId xmlns:p14="http://schemas.microsoft.com/office/powerpoint/2010/main" val="25513803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22C3EB2-8778-43F6-840C-633A453D91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0637" y="123825"/>
            <a:ext cx="8979057" cy="599122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D273AA3-296A-451E-9A8B-469A9D6047FF}"/>
              </a:ext>
            </a:extLst>
          </p:cNvPr>
          <p:cNvSpPr txBox="1"/>
          <p:nvPr/>
        </p:nvSpPr>
        <p:spPr>
          <a:xfrm>
            <a:off x="7015164" y="5100641"/>
            <a:ext cx="4343400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Overall Pearson correlation = 0.60, p &lt; 0001</a:t>
            </a:r>
          </a:p>
        </p:txBody>
      </p:sp>
    </p:spTree>
    <p:extLst>
      <p:ext uri="{BB962C8B-B14F-4D97-AF65-F5344CB8AC3E}">
        <p14:creationId xmlns:p14="http://schemas.microsoft.com/office/powerpoint/2010/main" val="5453405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0D6D2F2-99D3-4A31-9902-7D06088AD6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0999" y="0"/>
            <a:ext cx="9591676" cy="639999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0BB89AF-264C-401D-B459-E579FD0CDAD7}"/>
              </a:ext>
            </a:extLst>
          </p:cNvPr>
          <p:cNvSpPr txBox="1"/>
          <p:nvPr/>
        </p:nvSpPr>
        <p:spPr>
          <a:xfrm>
            <a:off x="7043739" y="5372103"/>
            <a:ext cx="4343400" cy="3693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Overall Pearson correlation = 0.46, p &lt; 0001</a:t>
            </a:r>
          </a:p>
        </p:txBody>
      </p:sp>
    </p:spTree>
    <p:extLst>
      <p:ext uri="{BB962C8B-B14F-4D97-AF65-F5344CB8AC3E}">
        <p14:creationId xmlns:p14="http://schemas.microsoft.com/office/powerpoint/2010/main" val="4476455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3</TotalTime>
  <Words>63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ssa Fentaye</dc:creator>
  <cp:lastModifiedBy>Kassa Fentaye</cp:lastModifiedBy>
  <cp:revision>87</cp:revision>
  <dcterms:created xsi:type="dcterms:W3CDTF">2020-10-03T17:39:44Z</dcterms:created>
  <dcterms:modified xsi:type="dcterms:W3CDTF">2021-04-06T12:03:13Z</dcterms:modified>
</cp:coreProperties>
</file>